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6858000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6F1C260-BC0B-4CC6-874E-13C49D13F926}" v="6" dt="2022-10-03T09:49:19.5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9" autoAdjust="0"/>
    <p:restoredTop sz="85304" autoAdjust="0"/>
  </p:normalViewPr>
  <p:slideViewPr>
    <p:cSldViewPr snapToGrid="0">
      <p:cViewPr varScale="1">
        <p:scale>
          <a:sx n="47" d="100"/>
          <a:sy n="47" d="100"/>
        </p:scale>
        <p:origin x="272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B12D7C-1812-4D25-92A4-C33B25077985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79663" y="1143000"/>
            <a:ext cx="20986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AFDD45-AF1F-48A7-8D47-448B4019DE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98217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Coronary flow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AFDD45-AF1F-48A7-8D47-448B4019DE5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4000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49770"/>
            <a:ext cx="5829300" cy="3509551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94662"/>
            <a:ext cx="5143500" cy="243381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4720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619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36700"/>
            <a:ext cx="1478756" cy="85428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36700"/>
            <a:ext cx="4350544" cy="85428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9646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8335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513159"/>
            <a:ext cx="5915025" cy="419325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746088"/>
            <a:ext cx="5915025" cy="220513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736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83500"/>
            <a:ext cx="2914650" cy="63960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83500"/>
            <a:ext cx="2914650" cy="63960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41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6702"/>
            <a:ext cx="5915025" cy="1948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71154"/>
            <a:ext cx="2901255" cy="121107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82228"/>
            <a:ext cx="2901255" cy="54160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71154"/>
            <a:ext cx="2915543" cy="121107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82228"/>
            <a:ext cx="2915543" cy="54160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11851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5222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4715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72042"/>
            <a:ext cx="2211884" cy="235214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51426"/>
            <a:ext cx="3471863" cy="716377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024188"/>
            <a:ext cx="2211884" cy="560268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0682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72042"/>
            <a:ext cx="2211884" cy="235214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51426"/>
            <a:ext cx="3471863" cy="716377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024188"/>
            <a:ext cx="2211884" cy="560268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313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36702"/>
            <a:ext cx="5915025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83500"/>
            <a:ext cx="5915025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343248"/>
            <a:ext cx="1543050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38814-F5B7-4D84-ACAF-200A694ACA70}" type="datetimeFigureOut">
              <a:rPr kumimoji="1" lang="ja-JP" altLang="en-US" smtClean="0"/>
              <a:t>2022/1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343248"/>
            <a:ext cx="2314575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343248"/>
            <a:ext cx="1543050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67B03-CC4F-4AA2-A38F-F5EF1A80D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40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jpg"/><Relationship Id="rId7" Type="http://schemas.openxmlformats.org/officeDocument/2006/relationships/image" Target="../media/image4.png"/><Relationship Id="rId12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g"/><Relationship Id="rId11" Type="http://schemas.openxmlformats.org/officeDocument/2006/relationships/image" Target="../media/image8.png"/><Relationship Id="rId5" Type="http://schemas.microsoft.com/office/2007/relationships/hdphoto" Target="../media/hdphoto1.wdp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5D1773B9-451E-58CE-07C2-B461998272A3}"/>
              </a:ext>
            </a:extLst>
          </p:cNvPr>
          <p:cNvGrpSpPr/>
          <p:nvPr/>
        </p:nvGrpSpPr>
        <p:grpSpPr>
          <a:xfrm>
            <a:off x="3494173" y="139414"/>
            <a:ext cx="3168000" cy="2375711"/>
            <a:chOff x="3494173" y="139414"/>
            <a:chExt cx="3168000" cy="2375711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2B286991-8C33-DEED-DADC-8FD1B97649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98" t="-3106" r="298" b="-3106"/>
            <a:stretch/>
          </p:blipFill>
          <p:spPr>
            <a:xfrm>
              <a:off x="3494173" y="139414"/>
              <a:ext cx="3168000" cy="237571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BBC47B4C-710D-B1C8-23C7-1A767BBC950F}"/>
                </a:ext>
              </a:extLst>
            </p:cNvPr>
            <p:cNvSpPr/>
            <p:nvPr/>
          </p:nvSpPr>
          <p:spPr>
            <a:xfrm>
              <a:off x="3494173" y="139415"/>
              <a:ext cx="355318" cy="27864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</a:rPr>
                <a:t>B</a:t>
              </a:r>
              <a:endParaRPr lang="ja-JP" altLang="en-US" sz="1600" b="1" dirty="0">
                <a:solidFill>
                  <a:schemeClr val="tx1"/>
                </a:solidFill>
                <a:latin typeface="Arial" panose="020B0604020202020204" pitchFamily="34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36D548B8-BD49-D084-22D2-AA7E8F09DE76}"/>
              </a:ext>
            </a:extLst>
          </p:cNvPr>
          <p:cNvGrpSpPr/>
          <p:nvPr/>
        </p:nvGrpSpPr>
        <p:grpSpPr>
          <a:xfrm>
            <a:off x="197202" y="5049932"/>
            <a:ext cx="3167944" cy="2376000"/>
            <a:chOff x="197202" y="5049932"/>
            <a:chExt cx="3167944" cy="2376000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ABF5ECB3-86F1-9E6A-3F33-9FD9172D57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52" t="30337" r="20693" b="34821"/>
            <a:stretch/>
          </p:blipFill>
          <p:spPr>
            <a:xfrm>
              <a:off x="197202" y="5049932"/>
              <a:ext cx="3167944" cy="2376000"/>
            </a:xfrm>
            <a:prstGeom prst="rect">
              <a:avLst/>
            </a:prstGeom>
          </p:spPr>
        </p:pic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B23B065D-F8A3-AF7B-E63F-6FEC7DC0B563}"/>
                </a:ext>
              </a:extLst>
            </p:cNvPr>
            <p:cNvSpPr/>
            <p:nvPr/>
          </p:nvSpPr>
          <p:spPr>
            <a:xfrm>
              <a:off x="197203" y="5049933"/>
              <a:ext cx="375108" cy="2985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E</a:t>
              </a:r>
              <a:endParaRPr lang="ja-JP" altLang="en-US" sz="1600" b="1" dirty="0">
                <a:solidFill>
                  <a:schemeClr val="bg1"/>
                </a:solidFill>
                <a:latin typeface="Arial" panose="020B0604020202020204" pitchFamily="34" charset="0"/>
              </a:endParaRPr>
            </a:p>
          </p:txBody>
        </p:sp>
        <p:cxnSp>
          <p:nvCxnSpPr>
            <p:cNvPr id="31" name="直線矢印コネクタ 30">
              <a:extLst>
                <a:ext uri="{FF2B5EF4-FFF2-40B4-BE49-F238E27FC236}">
                  <a16:creationId xmlns:a16="http://schemas.microsoft.com/office/drawing/2014/main" id="{654D97DA-0B1A-0ED7-AE89-63CDD27CF7D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70866" y="6458375"/>
              <a:ext cx="274320" cy="1524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5B43C13B-A30E-0B07-6554-6C27ACE69C13}"/>
              </a:ext>
            </a:extLst>
          </p:cNvPr>
          <p:cNvGrpSpPr/>
          <p:nvPr/>
        </p:nvGrpSpPr>
        <p:grpSpPr>
          <a:xfrm>
            <a:off x="3494173" y="2599490"/>
            <a:ext cx="3166084" cy="2376001"/>
            <a:chOff x="3494173" y="2599490"/>
            <a:chExt cx="3166084" cy="2376001"/>
          </a:xfrm>
        </p:grpSpPr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7364F663-1580-40B2-D20E-D651B21103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181" t="51451" r="2298"/>
            <a:stretch/>
          </p:blipFill>
          <p:spPr>
            <a:xfrm>
              <a:off x="3494173" y="2599492"/>
              <a:ext cx="3166084" cy="2375999"/>
            </a:xfrm>
            <a:prstGeom prst="rect">
              <a:avLst/>
            </a:prstGeom>
          </p:spPr>
        </p:pic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C20D7156-1DBB-DF02-FD03-A77B5BC1CC70}"/>
                </a:ext>
              </a:extLst>
            </p:cNvPr>
            <p:cNvSpPr/>
            <p:nvPr/>
          </p:nvSpPr>
          <p:spPr>
            <a:xfrm>
              <a:off x="3494176" y="2599490"/>
              <a:ext cx="378213" cy="362885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/>
            <a:p>
              <a:r>
                <a:rPr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D</a:t>
              </a:r>
              <a:endParaRPr lang="ja-JP" altLang="en-US" sz="1600" b="1" dirty="0">
                <a:solidFill>
                  <a:schemeClr val="bg1"/>
                </a:solidFill>
                <a:latin typeface="Arial" panose="020B0604020202020204" pitchFamily="34" charset="0"/>
              </a:endParaRPr>
            </a:p>
          </p:txBody>
        </p:sp>
        <p:cxnSp>
          <p:nvCxnSpPr>
            <p:cNvPr id="43" name="直線矢印コネクタ 42">
              <a:extLst>
                <a:ext uri="{FF2B5EF4-FFF2-40B4-BE49-F238E27FC236}">
                  <a16:creationId xmlns:a16="http://schemas.microsoft.com/office/drawing/2014/main" id="{49C9DFC2-5276-DFC7-36D9-B75B88BDC738}"/>
                </a:ext>
              </a:extLst>
            </p:cNvPr>
            <p:cNvCxnSpPr>
              <a:cxnSpLocks/>
            </p:cNvCxnSpPr>
            <p:nvPr/>
          </p:nvCxnSpPr>
          <p:spPr>
            <a:xfrm>
              <a:off x="4432332" y="3205429"/>
              <a:ext cx="0" cy="2605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矢印コネクタ 43">
              <a:extLst>
                <a:ext uri="{FF2B5EF4-FFF2-40B4-BE49-F238E27FC236}">
                  <a16:creationId xmlns:a16="http://schemas.microsoft.com/office/drawing/2014/main" id="{FD31D326-728B-C739-50D4-E2159DB3797F}"/>
                </a:ext>
              </a:extLst>
            </p:cNvPr>
            <p:cNvCxnSpPr>
              <a:cxnSpLocks/>
            </p:cNvCxnSpPr>
            <p:nvPr/>
          </p:nvCxnSpPr>
          <p:spPr>
            <a:xfrm>
              <a:off x="5649001" y="3193718"/>
              <a:ext cx="0" cy="2605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C215DDF1-9374-784F-85D6-5F43B97635DB}"/>
                </a:ext>
              </a:extLst>
            </p:cNvPr>
            <p:cNvSpPr txBox="1"/>
            <p:nvPr/>
          </p:nvSpPr>
          <p:spPr>
            <a:xfrm>
              <a:off x="3928491" y="2855164"/>
              <a:ext cx="223747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1400" dirty="0">
                  <a:solidFill>
                    <a:schemeClr val="bg1"/>
                  </a:solidFill>
                  <a:latin typeface="Arial" panose="020B0604020202020204" pitchFamily="34" charset="0"/>
                </a:rPr>
                <a:t>Coronary flow</a:t>
              </a:r>
              <a:endParaRPr kumimoji="1" lang="ja-JP" altLang="en-US" sz="1400" dirty="0">
                <a:solidFill>
                  <a:schemeClr val="bg1"/>
                </a:solidFill>
                <a:latin typeface="Arial" panose="020B0604020202020204" pitchFamily="34" charset="0"/>
              </a:endParaRP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215EA3CF-A40B-8D3F-9C20-F2D7ECE95CF2}"/>
              </a:ext>
            </a:extLst>
          </p:cNvPr>
          <p:cNvGrpSpPr/>
          <p:nvPr/>
        </p:nvGrpSpPr>
        <p:grpSpPr>
          <a:xfrm>
            <a:off x="189815" y="138446"/>
            <a:ext cx="3170195" cy="2377646"/>
            <a:chOff x="189815" y="138446"/>
            <a:chExt cx="3170195" cy="2377646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69970A5C-AE63-766A-F6C3-0124190D6DC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89815" y="138446"/>
              <a:ext cx="3170195" cy="2377646"/>
            </a:xfrm>
            <a:prstGeom prst="rect">
              <a:avLst/>
            </a:prstGeom>
          </p:spPr>
        </p:pic>
        <p:cxnSp>
          <p:nvCxnSpPr>
            <p:cNvPr id="38" name="直線矢印コネクタ 37">
              <a:extLst>
                <a:ext uri="{FF2B5EF4-FFF2-40B4-BE49-F238E27FC236}">
                  <a16:creationId xmlns:a16="http://schemas.microsoft.com/office/drawing/2014/main" id="{23AF218F-55D1-BF4C-B91D-56030D33DAF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74913" y="1638691"/>
              <a:ext cx="274320" cy="1524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0" name="図 29">
              <a:extLst>
                <a:ext uri="{FF2B5EF4-FFF2-40B4-BE49-F238E27FC236}">
                  <a16:creationId xmlns:a16="http://schemas.microsoft.com/office/drawing/2014/main" id="{D178E73D-8494-D41D-D00A-4D65EE77212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97202" y="159501"/>
              <a:ext cx="917495" cy="748976"/>
            </a:xfrm>
            <a:prstGeom prst="rect">
              <a:avLst/>
            </a:prstGeom>
          </p:spPr>
        </p:pic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EC88F425-69DF-A622-1AED-360F25FAE6D8}"/>
                </a:ext>
              </a:extLst>
            </p:cNvPr>
            <p:cNvSpPr/>
            <p:nvPr/>
          </p:nvSpPr>
          <p:spPr>
            <a:xfrm>
              <a:off x="197204" y="139416"/>
              <a:ext cx="375107" cy="422287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/>
            <a:p>
              <a:r>
                <a:rPr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A</a:t>
              </a:r>
              <a:endParaRPr lang="ja-JP" altLang="en-US" sz="1600" b="1" dirty="0">
                <a:solidFill>
                  <a:schemeClr val="bg1"/>
                </a:solidFill>
                <a:latin typeface="Arial" panose="020B0604020202020204" pitchFamily="34" charset="0"/>
              </a:endParaRP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5B736BC0-C8C0-21FC-5DF2-3AC8C0FF6141}"/>
              </a:ext>
            </a:extLst>
          </p:cNvPr>
          <p:cNvGrpSpPr/>
          <p:nvPr/>
        </p:nvGrpSpPr>
        <p:grpSpPr>
          <a:xfrm>
            <a:off x="197201" y="7514117"/>
            <a:ext cx="3170195" cy="2371550"/>
            <a:chOff x="197201" y="7514117"/>
            <a:chExt cx="3170195" cy="2371550"/>
          </a:xfrm>
        </p:grpSpPr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53353201-63F8-AD40-ECF6-5EA226FB753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97201" y="7514117"/>
              <a:ext cx="3170195" cy="2371550"/>
            </a:xfrm>
            <a:prstGeom prst="rect">
              <a:avLst/>
            </a:prstGeom>
          </p:spPr>
        </p:pic>
        <p:pic>
          <p:nvPicPr>
            <p:cNvPr id="32" name="図 31">
              <a:extLst>
                <a:ext uri="{FF2B5EF4-FFF2-40B4-BE49-F238E27FC236}">
                  <a16:creationId xmlns:a16="http://schemas.microsoft.com/office/drawing/2014/main" id="{641F051D-DB84-929A-C351-6AE7BEDECCC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97201" y="7514118"/>
              <a:ext cx="917495" cy="748976"/>
            </a:xfrm>
            <a:prstGeom prst="rect">
              <a:avLst/>
            </a:prstGeom>
          </p:spPr>
        </p:pic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733912A7-7389-2956-5E62-8AC61D188CB6}"/>
                </a:ext>
              </a:extLst>
            </p:cNvPr>
            <p:cNvSpPr/>
            <p:nvPr/>
          </p:nvSpPr>
          <p:spPr>
            <a:xfrm>
              <a:off x="197207" y="7514119"/>
              <a:ext cx="424193" cy="438985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/>
            <a:p>
              <a:r>
                <a:rPr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G</a:t>
              </a:r>
              <a:endParaRPr lang="ja-JP" altLang="en-US" sz="1600" b="1" dirty="0">
                <a:solidFill>
                  <a:schemeClr val="bg1"/>
                </a:solidFill>
                <a:latin typeface="Arial" panose="020B0604020202020204" pitchFamily="34" charset="0"/>
              </a:endParaRPr>
            </a:p>
          </p:txBody>
        </p:sp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2344905-0E1F-4A36-BE13-CECE58F89754}"/>
              </a:ext>
            </a:extLst>
          </p:cNvPr>
          <p:cNvSpPr txBox="1"/>
          <p:nvPr/>
        </p:nvSpPr>
        <p:spPr>
          <a:xfrm>
            <a:off x="-58597" y="433030"/>
            <a:ext cx="35385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</a:rPr>
              <a:t>Thrombosis in left coronary cusp 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42CE769E-A70C-AD72-DA07-761C0AAA8B16}"/>
              </a:ext>
            </a:extLst>
          </p:cNvPr>
          <p:cNvGrpSpPr/>
          <p:nvPr/>
        </p:nvGrpSpPr>
        <p:grpSpPr>
          <a:xfrm>
            <a:off x="197201" y="2595968"/>
            <a:ext cx="3170195" cy="2365453"/>
            <a:chOff x="197201" y="2595968"/>
            <a:chExt cx="3170195" cy="2365453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AE9A4BCB-F8B6-6A8D-B42F-3B01628C7BE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97201" y="2595968"/>
              <a:ext cx="3170195" cy="2365453"/>
            </a:xfrm>
            <a:prstGeom prst="rect">
              <a:avLst/>
            </a:prstGeom>
          </p:spPr>
        </p:pic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A31D6B70-7450-CCCC-836B-EA42BA05F139}"/>
                </a:ext>
              </a:extLst>
            </p:cNvPr>
            <p:cNvSpPr/>
            <p:nvPr/>
          </p:nvSpPr>
          <p:spPr>
            <a:xfrm>
              <a:off x="197203" y="2599491"/>
              <a:ext cx="442878" cy="724477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t"/>
            <a:lstStyle/>
            <a:p>
              <a:r>
                <a:rPr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C</a:t>
              </a:r>
              <a:endParaRPr lang="ja-JP" altLang="en-US" sz="1600" b="1" dirty="0">
                <a:solidFill>
                  <a:schemeClr val="bg1"/>
                </a:solidFill>
                <a:latin typeface="Arial" panose="020B0604020202020204" pitchFamily="34" charset="0"/>
              </a:endParaRPr>
            </a:p>
          </p:txBody>
        </p:sp>
        <p:cxnSp>
          <p:nvCxnSpPr>
            <p:cNvPr id="33" name="直線矢印コネクタ 32">
              <a:extLst>
                <a:ext uri="{FF2B5EF4-FFF2-40B4-BE49-F238E27FC236}">
                  <a16:creationId xmlns:a16="http://schemas.microsoft.com/office/drawing/2014/main" id="{1F456AA2-CC2D-994D-74A8-9573CF70C724}"/>
                </a:ext>
              </a:extLst>
            </p:cNvPr>
            <p:cNvCxnSpPr>
              <a:cxnSpLocks/>
            </p:cNvCxnSpPr>
            <p:nvPr/>
          </p:nvCxnSpPr>
          <p:spPr>
            <a:xfrm>
              <a:off x="2847372" y="3670627"/>
              <a:ext cx="0" cy="2605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矢印コネクタ 34">
              <a:extLst>
                <a:ext uri="{FF2B5EF4-FFF2-40B4-BE49-F238E27FC236}">
                  <a16:creationId xmlns:a16="http://schemas.microsoft.com/office/drawing/2014/main" id="{EEB6F492-8CA6-6E8A-DC2D-0CDF9CC66906}"/>
                </a:ext>
              </a:extLst>
            </p:cNvPr>
            <p:cNvCxnSpPr>
              <a:cxnSpLocks/>
            </p:cNvCxnSpPr>
            <p:nvPr/>
          </p:nvCxnSpPr>
          <p:spPr>
            <a:xfrm>
              <a:off x="2336929" y="3654096"/>
              <a:ext cx="0" cy="2605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矢印コネクタ 35">
              <a:extLst>
                <a:ext uri="{FF2B5EF4-FFF2-40B4-BE49-F238E27FC236}">
                  <a16:creationId xmlns:a16="http://schemas.microsoft.com/office/drawing/2014/main" id="{D6E237DD-56F6-D6CC-D4F3-384464E47F18}"/>
                </a:ext>
              </a:extLst>
            </p:cNvPr>
            <p:cNvCxnSpPr>
              <a:cxnSpLocks/>
            </p:cNvCxnSpPr>
            <p:nvPr/>
          </p:nvCxnSpPr>
          <p:spPr>
            <a:xfrm>
              <a:off x="3067291" y="3619279"/>
              <a:ext cx="0" cy="2605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矢印コネクタ 36">
              <a:extLst>
                <a:ext uri="{FF2B5EF4-FFF2-40B4-BE49-F238E27FC236}">
                  <a16:creationId xmlns:a16="http://schemas.microsoft.com/office/drawing/2014/main" id="{C2689D73-5DDA-5A6D-25B2-FADDD8F48023}"/>
                </a:ext>
              </a:extLst>
            </p:cNvPr>
            <p:cNvCxnSpPr>
              <a:cxnSpLocks/>
            </p:cNvCxnSpPr>
            <p:nvPr/>
          </p:nvCxnSpPr>
          <p:spPr>
            <a:xfrm>
              <a:off x="2592729" y="3723204"/>
              <a:ext cx="0" cy="2605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FA3D8A5F-1CF2-4E6F-A9B1-51F58038CC8C}"/>
                </a:ext>
              </a:extLst>
            </p:cNvPr>
            <p:cNvSpPr txBox="1"/>
            <p:nvPr/>
          </p:nvSpPr>
          <p:spPr>
            <a:xfrm>
              <a:off x="1870050" y="2753905"/>
              <a:ext cx="133527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1400" dirty="0">
                  <a:solidFill>
                    <a:schemeClr val="bg1"/>
                  </a:solidFill>
                  <a:latin typeface="Arial" panose="020B0604020202020204" pitchFamily="34" charset="0"/>
                </a:rPr>
                <a:t>Coronary flow</a:t>
              </a:r>
              <a:endParaRPr kumimoji="1" lang="ja-JP" altLang="en-US" sz="1400" dirty="0">
                <a:solidFill>
                  <a:schemeClr val="bg1"/>
                </a:solidFill>
                <a:latin typeface="Arial" panose="020B0604020202020204" pitchFamily="34" charset="0"/>
              </a:endParaRPr>
            </a:p>
          </p:txBody>
        </p:sp>
      </p:grp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D246AD1-A67C-4F42-93D0-1972F351B1C8}"/>
              </a:ext>
            </a:extLst>
          </p:cNvPr>
          <p:cNvSpPr txBox="1"/>
          <p:nvPr/>
        </p:nvSpPr>
        <p:spPr>
          <a:xfrm>
            <a:off x="796742" y="6737423"/>
            <a:ext cx="353850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</a:rPr>
              <a:t>Thrombosis </a:t>
            </a:r>
          </a:p>
          <a:p>
            <a:pPr algn="ctr"/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</a:rPr>
              <a:t>in left coronary cusp 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87FEAD09-79ED-5D5D-ADCC-EBE08F18FC95}"/>
              </a:ext>
            </a:extLst>
          </p:cNvPr>
          <p:cNvGrpSpPr/>
          <p:nvPr/>
        </p:nvGrpSpPr>
        <p:grpSpPr>
          <a:xfrm>
            <a:off x="3494173" y="5049932"/>
            <a:ext cx="3294440" cy="2376000"/>
            <a:chOff x="3494173" y="5049932"/>
            <a:chExt cx="3294440" cy="2376000"/>
          </a:xfrm>
        </p:grpSpPr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7748E6F3-1043-6B4B-CBED-FBEA640931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05" t="31172" r="21495" b="34053"/>
            <a:stretch/>
          </p:blipFill>
          <p:spPr>
            <a:xfrm>
              <a:off x="3494173" y="5049932"/>
              <a:ext cx="3170306" cy="2376000"/>
            </a:xfrm>
            <a:prstGeom prst="rect">
              <a:avLst/>
            </a:prstGeom>
          </p:spPr>
        </p:pic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EA915916-6F48-E5E9-7193-9FBE0AF894D0}"/>
                </a:ext>
              </a:extLst>
            </p:cNvPr>
            <p:cNvSpPr/>
            <p:nvPr/>
          </p:nvSpPr>
          <p:spPr>
            <a:xfrm>
              <a:off x="3494174" y="5049933"/>
              <a:ext cx="378212" cy="29660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</a:rPr>
                <a:t>F</a:t>
              </a:r>
              <a:endParaRPr lang="ja-JP" altLang="en-US" sz="1600" b="1" dirty="0">
                <a:solidFill>
                  <a:schemeClr val="bg1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E07D3FE2-C65C-4E6C-8FEA-BFED0A731FA4}"/>
                </a:ext>
              </a:extLst>
            </p:cNvPr>
            <p:cNvSpPr txBox="1"/>
            <p:nvPr/>
          </p:nvSpPr>
          <p:spPr>
            <a:xfrm>
              <a:off x="4551143" y="6845144"/>
              <a:ext cx="223747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1400" dirty="0">
                  <a:solidFill>
                    <a:schemeClr val="bg1"/>
                  </a:solidFill>
                  <a:latin typeface="Arial" panose="020B0604020202020204" pitchFamily="34" charset="0"/>
                </a:rPr>
                <a:t>Preserved coronary flow</a:t>
              </a:r>
              <a:endParaRPr kumimoji="1" lang="ja-JP" altLang="en-US" sz="1400" dirty="0">
                <a:solidFill>
                  <a:schemeClr val="bg1"/>
                </a:solidFill>
                <a:latin typeface="Arial" panose="020B0604020202020204" pitchFamily="34" charset="0"/>
              </a:endParaRPr>
            </a:p>
          </p:txBody>
        </p:sp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id="{21C19B97-0F43-4BC2-9F27-C09CA03B47F1}"/>
                </a:ext>
              </a:extLst>
            </p:cNvPr>
            <p:cNvCxnSpPr>
              <a:cxnSpLocks/>
            </p:cNvCxnSpPr>
            <p:nvPr/>
          </p:nvCxnSpPr>
          <p:spPr>
            <a:xfrm>
              <a:off x="5817836" y="6003671"/>
              <a:ext cx="0" cy="2605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矢印コネクタ 41">
              <a:extLst>
                <a:ext uri="{FF2B5EF4-FFF2-40B4-BE49-F238E27FC236}">
                  <a16:creationId xmlns:a16="http://schemas.microsoft.com/office/drawing/2014/main" id="{FA3EF3AD-F5B7-4BEF-885A-F2BDD25B2F2C}"/>
                </a:ext>
              </a:extLst>
            </p:cNvPr>
            <p:cNvCxnSpPr>
              <a:cxnSpLocks/>
            </p:cNvCxnSpPr>
            <p:nvPr/>
          </p:nvCxnSpPr>
          <p:spPr>
            <a:xfrm>
              <a:off x="5307393" y="6003181"/>
              <a:ext cx="0" cy="2605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矢印コネクタ 44">
              <a:extLst>
                <a:ext uri="{FF2B5EF4-FFF2-40B4-BE49-F238E27FC236}">
                  <a16:creationId xmlns:a16="http://schemas.microsoft.com/office/drawing/2014/main" id="{B91F29FE-C428-4F8B-8B1B-BE50A02DC46A}"/>
                </a:ext>
              </a:extLst>
            </p:cNvPr>
            <p:cNvCxnSpPr>
              <a:cxnSpLocks/>
            </p:cNvCxnSpPr>
            <p:nvPr/>
          </p:nvCxnSpPr>
          <p:spPr>
            <a:xfrm>
              <a:off x="6037755" y="6016489"/>
              <a:ext cx="0" cy="2605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矢印コネクタ 45">
              <a:extLst>
                <a:ext uri="{FF2B5EF4-FFF2-40B4-BE49-F238E27FC236}">
                  <a16:creationId xmlns:a16="http://schemas.microsoft.com/office/drawing/2014/main" id="{530CD215-CE52-4DA6-BC11-737EABD7C460}"/>
                </a:ext>
              </a:extLst>
            </p:cNvPr>
            <p:cNvCxnSpPr>
              <a:cxnSpLocks/>
            </p:cNvCxnSpPr>
            <p:nvPr/>
          </p:nvCxnSpPr>
          <p:spPr>
            <a:xfrm>
              <a:off x="5563193" y="6034860"/>
              <a:ext cx="0" cy="26050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22713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3</TotalTime>
  <Words>27</Words>
  <Application>Microsoft Office PowerPoint</Application>
  <PresentationFormat>ユーザー設定</PresentationFormat>
  <Paragraphs>1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翼 佐藤</dc:creator>
  <cp:lastModifiedBy>翼 佐藤</cp:lastModifiedBy>
  <cp:revision>20</cp:revision>
  <dcterms:created xsi:type="dcterms:W3CDTF">2022-08-18T05:15:22Z</dcterms:created>
  <dcterms:modified xsi:type="dcterms:W3CDTF">2022-11-27T14:42:26Z</dcterms:modified>
</cp:coreProperties>
</file>